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sldIdLst>
    <p:sldId id="270" r:id="rId2"/>
    <p:sldId id="274" r:id="rId3"/>
    <p:sldId id="275" r:id="rId4"/>
    <p:sldId id="278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1" autoAdjust="0"/>
    <p:restoredTop sz="94660"/>
  </p:normalViewPr>
  <p:slideViewPr>
    <p:cSldViewPr snapToGrid="0">
      <p:cViewPr varScale="1">
        <p:scale>
          <a:sx n="38" d="100"/>
          <a:sy n="38" d="100"/>
        </p:scale>
        <p:origin x="239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6120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9248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6607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269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1116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1028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2782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7285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943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6054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9634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00647F-2752-4FA2-BFDC-67FF9BBE3351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55E693-5751-401A-A606-7750CD2E721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0338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318AF03D-1F94-F948-81EA-2F7DC6E849FA}"/>
              </a:ext>
            </a:extLst>
          </p:cNvPr>
          <p:cNvSpPr txBox="1"/>
          <p:nvPr/>
        </p:nvSpPr>
        <p:spPr>
          <a:xfrm>
            <a:off x="702871" y="11597727"/>
            <a:ext cx="5639526" cy="5713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Supplementary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figure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1.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Forest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plot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of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associations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between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comorbidities and AKI in ICIs-treated patients.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 HTN</a:t>
            </a:r>
            <a:r>
              <a:rPr lang="zh-CN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hypertension; CHF: congestive heart failure; COPD: chronic obstructive pulmonary disease; AKI: acute kidney injury; ICIs: immune checkpoint inhibitors</a:t>
            </a:r>
            <a:endParaRPr kumimoji="1" lang="zh-CN" altLang="en-US" sz="1013" b="1" dirty="0">
              <a:latin typeface="Arial" panose="020B0604020202020204" pitchFamily="34" charset="0"/>
              <a:ea typeface="SimHei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613C6D5-E73F-431C-ACF8-1A08AD8C684C}"/>
              </a:ext>
            </a:extLst>
          </p:cNvPr>
          <p:cNvSpPr txBox="1"/>
          <p:nvPr/>
        </p:nvSpPr>
        <p:spPr>
          <a:xfrm>
            <a:off x="388895" y="3303244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B.</a:t>
            </a:r>
            <a:endParaRPr lang="zh-CN" altLang="en-US" sz="1000" b="1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85ACC999-F5FE-1346-A625-C70A1BC0160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37" t="34119" r="10561" b="33286"/>
          <a:stretch/>
        </p:blipFill>
        <p:spPr>
          <a:xfrm>
            <a:off x="466954" y="163210"/>
            <a:ext cx="5875443" cy="340884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00676282-8AC9-4E70-936E-3FF3F8DB8EE8}"/>
              </a:ext>
            </a:extLst>
          </p:cNvPr>
          <p:cNvSpPr txBox="1"/>
          <p:nvPr/>
        </p:nvSpPr>
        <p:spPr>
          <a:xfrm>
            <a:off x="469683" y="280251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A.</a:t>
            </a:r>
            <a:endParaRPr lang="zh-CN" altLang="en-US" sz="1000" b="1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F5F72E9F-379E-3047-B46D-B290B7283C6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37" t="38386" r="11025" b="36894"/>
          <a:stretch/>
        </p:blipFill>
        <p:spPr>
          <a:xfrm>
            <a:off x="386806" y="3549465"/>
            <a:ext cx="6250944" cy="2770202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C703C43A-135B-1140-BBD0-C0EB74CB8AD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49" t="37497" r="10249" b="36894"/>
          <a:stretch/>
        </p:blipFill>
        <p:spPr>
          <a:xfrm>
            <a:off x="466954" y="6338802"/>
            <a:ext cx="6391046" cy="291329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0642DDFA-55E9-4829-95DC-B2BF37FEEEF7}"/>
              </a:ext>
            </a:extLst>
          </p:cNvPr>
          <p:cNvSpPr txBox="1"/>
          <p:nvPr/>
        </p:nvSpPr>
        <p:spPr>
          <a:xfrm>
            <a:off x="386806" y="6215692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C.</a:t>
            </a:r>
            <a:endParaRPr lang="zh-CN" altLang="en-US" sz="1000" b="1" dirty="0"/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2771F88A-4A27-124B-8EB3-0C7771ADEA0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49" t="39274" r="9936" b="38682"/>
          <a:stretch/>
        </p:blipFill>
        <p:spPr>
          <a:xfrm>
            <a:off x="466954" y="9271227"/>
            <a:ext cx="6295827" cy="2460698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FC784E0D-20C4-4270-B8DA-62EF7F96C74E}"/>
              </a:ext>
            </a:extLst>
          </p:cNvPr>
          <p:cNvSpPr txBox="1"/>
          <p:nvPr/>
        </p:nvSpPr>
        <p:spPr>
          <a:xfrm>
            <a:off x="386806" y="9382138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D.</a:t>
            </a:r>
            <a:endParaRPr lang="zh-CN" alt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763543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318AF03D-1F94-F948-81EA-2F7DC6E849FA}"/>
              </a:ext>
            </a:extLst>
          </p:cNvPr>
          <p:cNvSpPr txBox="1"/>
          <p:nvPr/>
        </p:nvSpPr>
        <p:spPr>
          <a:xfrm>
            <a:off x="433264" y="6321134"/>
            <a:ext cx="6277717" cy="4020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Supplementary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figure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2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.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Forest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plot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of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associations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between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cancer types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and AKI in ICIs-treated patients.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KI: acute kidney injury; ICIs: immune checkpoint inhibitors</a:t>
            </a:r>
            <a:endParaRPr kumimoji="1" lang="zh-CN" altLang="en-US" sz="1013" b="1" dirty="0">
              <a:latin typeface="Arial" panose="020B0604020202020204" pitchFamily="34" charset="0"/>
              <a:ea typeface="SimHei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DB6F4B2-04EE-3645-B9FC-39789FFC10A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62" t="37497" r="9182" b="35304"/>
          <a:stretch/>
        </p:blipFill>
        <p:spPr>
          <a:xfrm>
            <a:off x="-45203" y="113137"/>
            <a:ext cx="6903203" cy="3226328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BD715F18-0BF9-410E-95DD-F54E56FCF1B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396" t="36559" r="11121" b="36717"/>
          <a:stretch/>
        </p:blipFill>
        <p:spPr>
          <a:xfrm>
            <a:off x="73397" y="3178243"/>
            <a:ext cx="6499227" cy="309235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0466F2E3-D29F-4621-A3C2-8283147458BB}"/>
              </a:ext>
            </a:extLst>
          </p:cNvPr>
          <p:cNvSpPr txBox="1"/>
          <p:nvPr/>
        </p:nvSpPr>
        <p:spPr>
          <a:xfrm>
            <a:off x="200076" y="136426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A.</a:t>
            </a:r>
            <a:endParaRPr lang="zh-CN" altLang="en-US" sz="10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428E8E7-F21E-4C28-8E59-80CD45C6BAE6}"/>
              </a:ext>
            </a:extLst>
          </p:cNvPr>
          <p:cNvSpPr txBox="1"/>
          <p:nvPr/>
        </p:nvSpPr>
        <p:spPr>
          <a:xfrm>
            <a:off x="200076" y="3228780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B.</a:t>
            </a:r>
            <a:endParaRPr lang="zh-CN" alt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14049438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318AF03D-1F94-F948-81EA-2F7DC6E849FA}"/>
              </a:ext>
            </a:extLst>
          </p:cNvPr>
          <p:cNvSpPr txBox="1"/>
          <p:nvPr/>
        </p:nvSpPr>
        <p:spPr>
          <a:xfrm>
            <a:off x="313601" y="10263364"/>
            <a:ext cx="654439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Supplementary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figure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3.</a:t>
            </a:r>
            <a:r>
              <a:rPr kumimoji="1" lang="en-US" altLang="zh-CN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Forest</a:t>
            </a:r>
            <a:r>
              <a:rPr kumimoji="1" lang="zh-CN" altLang="en-US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plot</a:t>
            </a:r>
            <a:r>
              <a:rPr kumimoji="1" lang="zh-CN" altLang="en-US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of</a:t>
            </a:r>
            <a:r>
              <a:rPr kumimoji="1" lang="zh-CN" altLang="en-US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associations</a:t>
            </a:r>
            <a:r>
              <a:rPr kumimoji="1" lang="zh-CN" altLang="en-US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between</a:t>
            </a:r>
            <a:r>
              <a:rPr kumimoji="1" lang="zh-CN" altLang="en-US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5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ICI-categories and AKI in ICIs-treated patients.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 AKI: acute kidney injury; ICIs: immune checkpoint inhibitors</a:t>
            </a:r>
            <a:endParaRPr kumimoji="1" lang="zh-CN" altLang="en-US" sz="1013" b="1" dirty="0">
              <a:latin typeface="Arial" panose="020B0604020202020204" pitchFamily="34" charset="0"/>
              <a:ea typeface="SimHei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13FA75A5-E28B-FD41-B701-79071B35616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57" t="38030" r="11860" b="37676"/>
          <a:stretch/>
        </p:blipFill>
        <p:spPr>
          <a:xfrm>
            <a:off x="406665" y="3843834"/>
            <a:ext cx="6135645" cy="275076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3F54D56F-EA71-499E-B73B-781A0EDCEE9F}"/>
              </a:ext>
            </a:extLst>
          </p:cNvPr>
          <p:cNvSpPr txBox="1"/>
          <p:nvPr/>
        </p:nvSpPr>
        <p:spPr>
          <a:xfrm>
            <a:off x="315690" y="3697395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B.</a:t>
            </a:r>
            <a:endParaRPr lang="zh-CN" altLang="en-US" sz="1000" b="1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33E6AF84-2EF7-264E-9751-B66A3117895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34" t="36757" r="10665" b="34899"/>
          <a:stretch/>
        </p:blipFill>
        <p:spPr>
          <a:xfrm>
            <a:off x="313601" y="446146"/>
            <a:ext cx="6461522" cy="3288933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71B1C7DE-9D26-4F25-A07C-A909E6BBE709}"/>
              </a:ext>
            </a:extLst>
          </p:cNvPr>
          <p:cNvSpPr txBox="1"/>
          <p:nvPr/>
        </p:nvSpPr>
        <p:spPr>
          <a:xfrm>
            <a:off x="396478" y="312894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A.</a:t>
            </a:r>
            <a:endParaRPr lang="zh-CN" altLang="en-US" sz="1000" b="1" dirty="0"/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E4B1EFF5-D8D7-2842-89FD-BD2CF091C90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54" t="35641" r="11465" b="36015"/>
          <a:stretch/>
        </p:blipFill>
        <p:spPr>
          <a:xfrm>
            <a:off x="313601" y="6869739"/>
            <a:ext cx="6336794" cy="3288934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9221E9B0-4FEF-4BCA-9AD9-CAB1B47FBC35}"/>
              </a:ext>
            </a:extLst>
          </p:cNvPr>
          <p:cNvSpPr txBox="1"/>
          <p:nvPr/>
        </p:nvSpPr>
        <p:spPr>
          <a:xfrm>
            <a:off x="291034" y="6882483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C.</a:t>
            </a:r>
            <a:endParaRPr lang="zh-CN" alt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7781529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BC37C698-CA49-C940-B7F4-CCB1C8BA986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11" t="37319" r="10688" b="36046"/>
          <a:stretch/>
        </p:blipFill>
        <p:spPr>
          <a:xfrm>
            <a:off x="227532" y="4206907"/>
            <a:ext cx="6402936" cy="303566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318AF03D-1F94-F948-81EA-2F7DC6E849FA}"/>
              </a:ext>
            </a:extLst>
          </p:cNvPr>
          <p:cNvSpPr txBox="1"/>
          <p:nvPr/>
        </p:nvSpPr>
        <p:spPr>
          <a:xfrm>
            <a:off x="439263" y="7137566"/>
            <a:ext cx="6125008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Supplementary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figure</a:t>
            </a:r>
            <a:r>
              <a:rPr kumimoji="1" lang="zh-CN" altLang="en-US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4.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Forest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plot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of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associations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between</a:t>
            </a:r>
            <a:r>
              <a:rPr kumimoji="1" lang="zh-CN" altLang="en-US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r>
              <a:rPr kumimoji="1" lang="en-US" altLang="zh-CN" sz="1000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demographic characteristics and AKI in ICIs-treated patients.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KI: acute kidney injury; ICIs: immune checkpoint inhibitors</a:t>
            </a:r>
            <a:r>
              <a:rPr kumimoji="1" lang="en-US" altLang="zh-CN" sz="1013" b="1" dirty="0">
                <a:latin typeface="Arial" panose="020B0604020202020204" pitchFamily="34" charset="0"/>
                <a:ea typeface="SimHei" panose="02010609060101010101" pitchFamily="49" charset="-122"/>
                <a:cs typeface="Arial" panose="020B0604020202020204" pitchFamily="34" charset="0"/>
              </a:rPr>
              <a:t> </a:t>
            </a:r>
            <a:endParaRPr kumimoji="1" lang="zh-CN" altLang="en-US" sz="1013" b="1" dirty="0">
              <a:latin typeface="Arial" panose="020B0604020202020204" pitchFamily="34" charset="0"/>
              <a:ea typeface="SimHei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DDCCA06-05F8-0048-A304-123A8B1DA5E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28" t="33317" r="11447" b="33072"/>
          <a:stretch/>
        </p:blipFill>
        <p:spPr>
          <a:xfrm>
            <a:off x="430327" y="209758"/>
            <a:ext cx="6266338" cy="389471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90AC0D6-E6D6-4369-90B3-64D524A8016B}"/>
              </a:ext>
            </a:extLst>
          </p:cNvPr>
          <p:cNvSpPr txBox="1"/>
          <p:nvPr/>
        </p:nvSpPr>
        <p:spPr>
          <a:xfrm>
            <a:off x="439262" y="209758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A.</a:t>
            </a:r>
            <a:endParaRPr lang="zh-CN" altLang="en-US" sz="100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388D414-E997-4AEF-86E4-6ECC46676033}"/>
              </a:ext>
            </a:extLst>
          </p:cNvPr>
          <p:cNvSpPr txBox="1"/>
          <p:nvPr/>
        </p:nvSpPr>
        <p:spPr>
          <a:xfrm>
            <a:off x="358474" y="4206907"/>
            <a:ext cx="4663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B.</a:t>
            </a:r>
            <a:endParaRPr lang="zh-CN" alt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82533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9</TotalTime>
  <Words>149</Words>
  <Application>Microsoft Office PowerPoint</Application>
  <PresentationFormat>宽屏</PresentationFormat>
  <Paragraphs>15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冯敏</dc:creator>
  <cp:lastModifiedBy>Administrator</cp:lastModifiedBy>
  <cp:revision>34</cp:revision>
  <dcterms:created xsi:type="dcterms:W3CDTF">2022-05-12T14:20:11Z</dcterms:created>
  <dcterms:modified xsi:type="dcterms:W3CDTF">2022-06-18T08:11:48Z</dcterms:modified>
</cp:coreProperties>
</file>